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192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Applications:TB%20PROJECT:NSW%20database%20Peter%20Feb_14_2013:2009-2013%20NSW%20TB%20Beijing%20EAI%20comparison%20paper%20analysis:2009-2013%20NSW%20TB%201692%20HP-Rare%20format_Allelic%20Richnes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04702794503628"/>
          <c:y val="0.0482658433747833"/>
          <c:w val="0.843100694766095"/>
          <c:h val="0.627062445398704"/>
        </c:manualLayout>
      </c:layout>
      <c:barChart>
        <c:barDir val="col"/>
        <c:grouping val="clustered"/>
        <c:varyColors val="0"/>
        <c:ser>
          <c:idx val="0"/>
          <c:order val="0"/>
          <c:tx>
            <c:v>EAI</c:v>
          </c:tx>
          <c:spPr>
            <a:solidFill>
              <a:schemeClr val="tx1"/>
            </a:solidFill>
            <a:ln w="25400">
              <a:solidFill>
                <a:schemeClr val="tx1"/>
              </a:solidFill>
              <a:prstDash val="solid"/>
            </a:ln>
          </c:spPr>
          <c:invertIfNegative val="0"/>
          <c:cat>
            <c:strRef>
              <c:f>'Figure '!$C$2:$Z$2</c:f>
              <c:strCache>
                <c:ptCount val="24"/>
                <c:pt idx="0">
                  <c:v>MIRU2   </c:v>
                </c:pt>
                <c:pt idx="1">
                  <c:v>MIRU4   </c:v>
                </c:pt>
                <c:pt idx="2">
                  <c:v>MIRU10  </c:v>
                </c:pt>
                <c:pt idx="3">
                  <c:v>MIRU16  </c:v>
                </c:pt>
                <c:pt idx="4">
                  <c:v>MIRU20  </c:v>
                </c:pt>
                <c:pt idx="5">
                  <c:v>MIRU23  </c:v>
                </c:pt>
                <c:pt idx="6">
                  <c:v>MIRU24  </c:v>
                </c:pt>
                <c:pt idx="7">
                  <c:v>MIRU26  </c:v>
                </c:pt>
                <c:pt idx="8">
                  <c:v>MIRU27  </c:v>
                </c:pt>
                <c:pt idx="9">
                  <c:v>MIRU31  </c:v>
                </c:pt>
                <c:pt idx="10">
                  <c:v>MIRU39  </c:v>
                </c:pt>
                <c:pt idx="11">
                  <c:v>MIRU40  </c:v>
                </c:pt>
                <c:pt idx="12">
                  <c:v>MIRU424 </c:v>
                </c:pt>
                <c:pt idx="13">
                  <c:v>MIRU577 </c:v>
                </c:pt>
                <c:pt idx="14">
                  <c:v>MIRU1955</c:v>
                </c:pt>
                <c:pt idx="15">
                  <c:v>MIRU2163</c:v>
                </c:pt>
                <c:pt idx="16">
                  <c:v>MIRU2165</c:v>
                </c:pt>
                <c:pt idx="17">
                  <c:v>MIRU2347</c:v>
                </c:pt>
                <c:pt idx="18">
                  <c:v>MIRU2401</c:v>
                </c:pt>
                <c:pt idx="19">
                  <c:v>MIRU2461</c:v>
                </c:pt>
                <c:pt idx="20">
                  <c:v>MIRU3171</c:v>
                </c:pt>
                <c:pt idx="21">
                  <c:v>MIRU3690</c:v>
                </c:pt>
                <c:pt idx="22">
                  <c:v>MIRU4052</c:v>
                </c:pt>
                <c:pt idx="23">
                  <c:v>MIRU4156</c:v>
                </c:pt>
              </c:strCache>
            </c:strRef>
          </c:cat>
          <c:val>
            <c:numRef>
              <c:f>'Figure '!$C$3:$Z$3</c:f>
              <c:numCache>
                <c:formatCode>General</c:formatCode>
                <c:ptCount val="24"/>
                <c:pt idx="0">
                  <c:v>1.9936</c:v>
                </c:pt>
                <c:pt idx="1">
                  <c:v>5.120499999999994</c:v>
                </c:pt>
                <c:pt idx="2">
                  <c:v>3.1964</c:v>
                </c:pt>
                <c:pt idx="3">
                  <c:v>2.6878</c:v>
                </c:pt>
                <c:pt idx="4">
                  <c:v>1.7527</c:v>
                </c:pt>
                <c:pt idx="5">
                  <c:v>3.9655</c:v>
                </c:pt>
                <c:pt idx="6">
                  <c:v>1.8372</c:v>
                </c:pt>
                <c:pt idx="7">
                  <c:v>1.5609</c:v>
                </c:pt>
                <c:pt idx="8">
                  <c:v>2.2146</c:v>
                </c:pt>
                <c:pt idx="9">
                  <c:v>3.6175</c:v>
                </c:pt>
                <c:pt idx="10">
                  <c:v>3.3738</c:v>
                </c:pt>
                <c:pt idx="11">
                  <c:v>3.6872</c:v>
                </c:pt>
                <c:pt idx="12">
                  <c:v>2.4912</c:v>
                </c:pt>
                <c:pt idx="13">
                  <c:v>3.3967</c:v>
                </c:pt>
                <c:pt idx="14">
                  <c:v>7.8473</c:v>
                </c:pt>
                <c:pt idx="15">
                  <c:v>7.5361</c:v>
                </c:pt>
                <c:pt idx="16">
                  <c:v>5.9698</c:v>
                </c:pt>
                <c:pt idx="17">
                  <c:v>1.5235</c:v>
                </c:pt>
                <c:pt idx="18">
                  <c:v>2.3287</c:v>
                </c:pt>
                <c:pt idx="19">
                  <c:v>5.2018</c:v>
                </c:pt>
                <c:pt idx="20">
                  <c:v>2.4092</c:v>
                </c:pt>
                <c:pt idx="21">
                  <c:v>5.610199999999994</c:v>
                </c:pt>
                <c:pt idx="22">
                  <c:v>5.6968</c:v>
                </c:pt>
                <c:pt idx="23">
                  <c:v>1.4301</c:v>
                </c:pt>
              </c:numCache>
            </c:numRef>
          </c:val>
        </c:ser>
        <c:ser>
          <c:idx val="1"/>
          <c:order val="1"/>
          <c:tx>
            <c:v>Beijing</c:v>
          </c:tx>
          <c:spPr>
            <a:solidFill>
              <a:schemeClr val="bg1">
                <a:lumMod val="50000"/>
              </a:schemeClr>
            </a:solidFill>
            <a:ln w="25400">
              <a:solidFill>
                <a:schemeClr val="bg1">
                  <a:lumMod val="50000"/>
                </a:schemeClr>
              </a:solidFill>
            </a:ln>
          </c:spPr>
          <c:invertIfNegative val="0"/>
          <c:val>
            <c:numRef>
              <c:f>'Figure '!$C$4:$Z$4</c:f>
              <c:numCache>
                <c:formatCode>General</c:formatCode>
                <c:ptCount val="24"/>
                <c:pt idx="0">
                  <c:v>1.1489</c:v>
                </c:pt>
                <c:pt idx="1">
                  <c:v>1.4782</c:v>
                </c:pt>
                <c:pt idx="2">
                  <c:v>2.5024</c:v>
                </c:pt>
                <c:pt idx="3">
                  <c:v>2.0154</c:v>
                </c:pt>
                <c:pt idx="4">
                  <c:v>1.356</c:v>
                </c:pt>
                <c:pt idx="5">
                  <c:v>1.9337</c:v>
                </c:pt>
                <c:pt idx="6">
                  <c:v>1.1447</c:v>
                </c:pt>
                <c:pt idx="7">
                  <c:v>4.427799999999999</c:v>
                </c:pt>
                <c:pt idx="8">
                  <c:v>2.075899999999999</c:v>
                </c:pt>
                <c:pt idx="9">
                  <c:v>2.5306</c:v>
                </c:pt>
                <c:pt idx="10">
                  <c:v>2.7952</c:v>
                </c:pt>
                <c:pt idx="11">
                  <c:v>3.6608</c:v>
                </c:pt>
                <c:pt idx="12">
                  <c:v>3.399799999999999</c:v>
                </c:pt>
                <c:pt idx="13">
                  <c:v>2.0365</c:v>
                </c:pt>
                <c:pt idx="14">
                  <c:v>4.174899999999996</c:v>
                </c:pt>
                <c:pt idx="15">
                  <c:v>5.5371</c:v>
                </c:pt>
                <c:pt idx="16">
                  <c:v>2.4242</c:v>
                </c:pt>
                <c:pt idx="17">
                  <c:v>1.4373</c:v>
                </c:pt>
                <c:pt idx="18">
                  <c:v>1.911899999999999</c:v>
                </c:pt>
                <c:pt idx="19">
                  <c:v>1.5364</c:v>
                </c:pt>
                <c:pt idx="20">
                  <c:v>2.2793</c:v>
                </c:pt>
                <c:pt idx="21">
                  <c:v>3.6845</c:v>
                </c:pt>
                <c:pt idx="22">
                  <c:v>5.7112</c:v>
                </c:pt>
                <c:pt idx="23">
                  <c:v>3.926899999999998</c:v>
                </c:pt>
              </c:numCache>
            </c:numRef>
          </c:val>
        </c:ser>
        <c:ser>
          <c:idx val="2"/>
          <c:order val="2"/>
          <c:tx>
            <c:v>Other lineages</c:v>
          </c:tx>
          <c:spPr>
            <a:pattFill prst="ltHorz">
              <a:fgClr>
                <a:schemeClr val="bg1"/>
              </a:fgClr>
              <a:bgClr>
                <a:prstClr val="white"/>
              </a:bgClr>
            </a:pattFill>
            <a:ln w="25400">
              <a:solidFill>
                <a:schemeClr val="tx1"/>
              </a:solidFill>
            </a:ln>
          </c:spPr>
          <c:invertIfNegative val="0"/>
          <c:val>
            <c:numRef>
              <c:f>'Figure '!$C$5:$Z$5</c:f>
              <c:numCache>
                <c:formatCode>0.000</c:formatCode>
                <c:ptCount val="24"/>
                <c:pt idx="0">
                  <c:v>1.18945</c:v>
                </c:pt>
                <c:pt idx="1">
                  <c:v>2.0893</c:v>
                </c:pt>
                <c:pt idx="2">
                  <c:v>2.9197375</c:v>
                </c:pt>
                <c:pt idx="3">
                  <c:v>2.50831875</c:v>
                </c:pt>
                <c:pt idx="4">
                  <c:v>1.6629375</c:v>
                </c:pt>
                <c:pt idx="5">
                  <c:v>2.16256875</c:v>
                </c:pt>
                <c:pt idx="6">
                  <c:v>1.21851875</c:v>
                </c:pt>
                <c:pt idx="7">
                  <c:v>3.17851875</c:v>
                </c:pt>
                <c:pt idx="8">
                  <c:v>1.715125</c:v>
                </c:pt>
                <c:pt idx="9">
                  <c:v>2.42375</c:v>
                </c:pt>
                <c:pt idx="10">
                  <c:v>1.39554375</c:v>
                </c:pt>
                <c:pt idx="11">
                  <c:v>3.5399875</c:v>
                </c:pt>
                <c:pt idx="12">
                  <c:v>2.94315625</c:v>
                </c:pt>
                <c:pt idx="13">
                  <c:v>2.60293125</c:v>
                </c:pt>
                <c:pt idx="14">
                  <c:v>2.57961875</c:v>
                </c:pt>
                <c:pt idx="15">
                  <c:v>3.83470625</c:v>
                </c:pt>
                <c:pt idx="16">
                  <c:v>2.611499999999999</c:v>
                </c:pt>
                <c:pt idx="17">
                  <c:v>1.99740625</c:v>
                </c:pt>
                <c:pt idx="18">
                  <c:v>1.7105875</c:v>
                </c:pt>
                <c:pt idx="19">
                  <c:v>1.9341375</c:v>
                </c:pt>
                <c:pt idx="20">
                  <c:v>2.45879375</c:v>
                </c:pt>
                <c:pt idx="21">
                  <c:v>3.6617875</c:v>
                </c:pt>
                <c:pt idx="22">
                  <c:v>4.843524999999984</c:v>
                </c:pt>
                <c:pt idx="23">
                  <c:v>2.608843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1965480"/>
        <c:axId val="-2132396536"/>
      </c:barChart>
      <c:catAx>
        <c:axId val="-21319654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400">
                    <a:latin typeface="Times New Roman"/>
                    <a:cs typeface="Times New Roman"/>
                  </a:defRPr>
                </a:pPr>
                <a:r>
                  <a:rPr lang="en-US" sz="1400">
                    <a:latin typeface="Times New Roman"/>
                    <a:cs typeface="Times New Roman"/>
                  </a:rPr>
                  <a:t>MIRU</a:t>
                </a:r>
                <a:r>
                  <a:rPr lang="en-US" sz="1400" baseline="0">
                    <a:latin typeface="Times New Roman"/>
                    <a:cs typeface="Times New Roman"/>
                  </a:rPr>
                  <a:t> alleles</a:t>
                </a:r>
                <a:endParaRPr lang="en-US" sz="1400">
                  <a:latin typeface="Times New Roman"/>
                  <a:cs typeface="Times New Roman"/>
                </a:endParaRPr>
              </a:p>
            </c:rich>
          </c:tx>
          <c:layout>
            <c:manualLayout>
              <c:xMode val="edge"/>
              <c:yMode val="edge"/>
              <c:x val="0.44541065308013"/>
              <c:y val="0.83420808906651"/>
            </c:manualLayout>
          </c:layout>
          <c:overlay val="0"/>
        </c:title>
        <c:majorTickMark val="none"/>
        <c:minorTickMark val="none"/>
        <c:tickLblPos val="nextTo"/>
        <c:txPr>
          <a:bodyPr/>
          <a:lstStyle/>
          <a:p>
            <a:pPr>
              <a:defRPr sz="1200">
                <a:latin typeface="Times New Roman"/>
                <a:cs typeface="Times New Roman"/>
              </a:defRPr>
            </a:pPr>
            <a:endParaRPr lang="en-US"/>
          </a:p>
        </c:txPr>
        <c:crossAx val="-2132396536"/>
        <c:crosses val="autoZero"/>
        <c:auto val="1"/>
        <c:lblAlgn val="ctr"/>
        <c:lblOffset val="100"/>
        <c:noMultiLvlLbl val="0"/>
      </c:catAx>
      <c:valAx>
        <c:axId val="-2132396536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sz="1400">
                    <a:latin typeface="Times New Roman"/>
                    <a:cs typeface="Times New Roman"/>
                  </a:defRPr>
                </a:pPr>
                <a:r>
                  <a:rPr lang="en-US" sz="1400">
                    <a:latin typeface="Times New Roman"/>
                    <a:cs typeface="Times New Roman"/>
                  </a:rPr>
                  <a:t>Number</a:t>
                </a:r>
                <a:r>
                  <a:rPr lang="en-US" sz="1400" baseline="0">
                    <a:latin typeface="Times New Roman"/>
                    <a:cs typeface="Times New Roman"/>
                  </a:rPr>
                  <a:t> of allelic variation</a:t>
                </a:r>
                <a:endParaRPr lang="en-US" sz="1400">
                  <a:latin typeface="Times New Roman"/>
                  <a:cs typeface="Times New Roman"/>
                </a:endParaRPr>
              </a:p>
            </c:rich>
          </c:tx>
          <c:layout>
            <c:manualLayout>
              <c:xMode val="edge"/>
              <c:yMode val="edge"/>
              <c:x val="0.00888037188122569"/>
              <c:y val="0.166421737328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400">
                <a:latin typeface="Times New Roman"/>
                <a:cs typeface="Times New Roman"/>
              </a:defRPr>
            </a:pPr>
            <a:endParaRPr lang="en-US"/>
          </a:p>
        </c:txPr>
        <c:crossAx val="-21319654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12280623745561"/>
          <c:y val="0.867972849657459"/>
          <c:w val="0.562820194534507"/>
          <c:h val="0.129288329866739"/>
        </c:manualLayout>
      </c:layout>
      <c:overlay val="0"/>
      <c:txPr>
        <a:bodyPr/>
        <a:lstStyle/>
        <a:p>
          <a:pPr>
            <a:defRPr sz="1400">
              <a:latin typeface="Times New Roman"/>
              <a:cs typeface="Times New Roman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302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7857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602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40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499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293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621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035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689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677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386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CF9E61-AF3C-2847-BEC4-F63228999D59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168FFD-E7A2-3A4B-8D67-9BB5780A7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386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3219272741"/>
              </p:ext>
            </p:extLst>
          </p:nvPr>
        </p:nvGraphicFramePr>
        <p:xfrm>
          <a:off x="412750" y="1730376"/>
          <a:ext cx="8096250" cy="41116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/>
          <p:cNvSpPr/>
          <p:nvPr/>
        </p:nvSpPr>
        <p:spPr>
          <a:xfrm>
            <a:off x="1127124" y="454710"/>
            <a:ext cx="617537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/>
                <a:cs typeface="Times New Roman"/>
              </a:rPr>
              <a:t>S2 Fig. </a:t>
            </a:r>
            <a:r>
              <a:rPr lang="en-AU" dirty="0">
                <a:latin typeface="Times New Roman"/>
                <a:cs typeface="Times New Roman"/>
              </a:rPr>
              <a:t>Comparison of MIRU-24 loci allelic richness for EAI and Beijing strain lineages</a:t>
            </a:r>
          </a:p>
        </p:txBody>
      </p:sp>
    </p:spTree>
    <p:extLst>
      <p:ext uri="{BB962C8B-B14F-4D97-AF65-F5344CB8AC3E}">
        <p14:creationId xmlns:p14="http://schemas.microsoft.com/office/powerpoint/2010/main" val="3644313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3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lziijargal Gurjav</dc:creator>
  <cp:lastModifiedBy>Ulziijargal Gurjav</cp:lastModifiedBy>
  <cp:revision>1</cp:revision>
  <dcterms:created xsi:type="dcterms:W3CDTF">2016-09-24T06:56:30Z</dcterms:created>
  <dcterms:modified xsi:type="dcterms:W3CDTF">2016-09-24T06:58:59Z</dcterms:modified>
</cp:coreProperties>
</file>